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913" autoAdjust="0"/>
  </p:normalViewPr>
  <p:slideViewPr>
    <p:cSldViewPr snapToGrid="0" snapToObjects="1">
      <p:cViewPr>
        <p:scale>
          <a:sx n="50" d="100"/>
          <a:sy n="50" d="100"/>
        </p:scale>
        <p:origin x="-1776" y="-12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792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A7A834-87EB-497A-911F-CA83418D9B35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757681-6312-49CB-88EF-8FF8780142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01345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-year RFS</a:t>
            </a:r>
          </a:p>
          <a:p>
            <a:pPr algn="l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A low:87.2%</a:t>
            </a:r>
          </a:p>
          <a:p>
            <a:pPr algn="l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A high:70.6%</a:t>
            </a:r>
            <a:endParaRPr lang="ja-JP" alt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 smtClean="0"/>
          </a:p>
          <a:p>
            <a:endParaRPr kumimoji="1" lang="en-US" altLang="ja-JP" dirty="0" smtClean="0"/>
          </a:p>
          <a:p>
            <a:pPr algn="l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-year RFS</a:t>
            </a:r>
          </a:p>
          <a:p>
            <a:pPr algn="l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A15-3 low:89.3%</a:t>
            </a:r>
          </a:p>
          <a:p>
            <a:pPr algn="l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A15-3 high:71.8%</a:t>
            </a:r>
            <a:endParaRPr lang="ja-JP" altLang="en-US" sz="1200" b="1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757681-6312-49CB-88EF-8FF8780142D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9328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5009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7416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4049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2398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4271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860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5677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3393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6100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2351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607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BE2CC-A1A4-1246-B7A9-B79E69B14224}" type="datetimeFigureOut">
              <a:rPr kumimoji="1" lang="ja-JP" altLang="en-US" smtClean="0"/>
              <a:t>2018/2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DC2839-2126-FD49-9724-02F70400E4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101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67199" y="2293307"/>
            <a:ext cx="3213100" cy="2197100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6997" y="2293307"/>
            <a:ext cx="3175000" cy="2171700"/>
          </a:xfrm>
          <a:prstGeom prst="rect">
            <a:avLst/>
          </a:prstGeom>
        </p:spPr>
      </p:pic>
      <p:sp>
        <p:nvSpPr>
          <p:cNvPr id="10" name="タイトル 1"/>
          <p:cNvSpPr txBox="1">
            <a:spLocks/>
          </p:cNvSpPr>
          <p:nvPr/>
        </p:nvSpPr>
        <p:spPr>
          <a:xfrm>
            <a:off x="743303" y="1665482"/>
            <a:ext cx="2684531" cy="369638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 CEA (All patients)</a:t>
            </a:r>
            <a:endParaRPr lang="ja-JP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タイトル 1"/>
          <p:cNvSpPr txBox="1">
            <a:spLocks/>
          </p:cNvSpPr>
          <p:nvPr/>
        </p:nvSpPr>
        <p:spPr>
          <a:xfrm>
            <a:off x="4995989" y="1667893"/>
            <a:ext cx="2800646" cy="369638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 CA15-3 (All patients)</a:t>
            </a:r>
            <a:endParaRPr lang="ja-JP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タイトル 1"/>
          <p:cNvSpPr txBox="1">
            <a:spLocks/>
          </p:cNvSpPr>
          <p:nvPr/>
        </p:nvSpPr>
        <p:spPr>
          <a:xfrm>
            <a:off x="1811280" y="2955258"/>
            <a:ext cx="1632778" cy="369638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gh: n=191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タイトル 1"/>
          <p:cNvSpPr txBox="1">
            <a:spLocks/>
          </p:cNvSpPr>
          <p:nvPr/>
        </p:nvSpPr>
        <p:spPr>
          <a:xfrm>
            <a:off x="2287089" y="2206715"/>
            <a:ext cx="1632778" cy="369638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w: n=885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タイトル 1"/>
          <p:cNvSpPr txBox="1">
            <a:spLocks/>
          </p:cNvSpPr>
          <p:nvPr/>
        </p:nvSpPr>
        <p:spPr>
          <a:xfrm>
            <a:off x="1909174" y="3503144"/>
            <a:ext cx="1128446" cy="369638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&lt;0.0001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タイトル 1"/>
          <p:cNvSpPr txBox="1">
            <a:spLocks/>
          </p:cNvSpPr>
          <p:nvPr/>
        </p:nvSpPr>
        <p:spPr>
          <a:xfrm>
            <a:off x="5967475" y="2973639"/>
            <a:ext cx="1632778" cy="369638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gh: n=314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タイトル 1"/>
          <p:cNvSpPr txBox="1">
            <a:spLocks/>
          </p:cNvSpPr>
          <p:nvPr/>
        </p:nvSpPr>
        <p:spPr>
          <a:xfrm>
            <a:off x="6970775" y="2190904"/>
            <a:ext cx="1632778" cy="369638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w: n=762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タイトル 1"/>
          <p:cNvSpPr txBox="1">
            <a:spLocks/>
          </p:cNvSpPr>
          <p:nvPr/>
        </p:nvSpPr>
        <p:spPr>
          <a:xfrm>
            <a:off x="6201912" y="3503144"/>
            <a:ext cx="1128446" cy="369638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5782498" y="395388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ja-JP" altLang="en-US" dirty="0"/>
          </a:p>
        </p:txBody>
      </p:sp>
      <p:sp>
        <p:nvSpPr>
          <p:cNvPr id="21" name="タイトル 1"/>
          <p:cNvSpPr txBox="1">
            <a:spLocks/>
          </p:cNvSpPr>
          <p:nvPr/>
        </p:nvSpPr>
        <p:spPr>
          <a:xfrm>
            <a:off x="581568" y="4323626"/>
            <a:ext cx="4144743" cy="724074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No. at risk</a:t>
            </a:r>
          </a:p>
          <a:p>
            <a:pPr algn="l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low     885 757 673 559 470 400 318 217 143   65   18    0</a:t>
            </a:r>
          </a:p>
          <a:p>
            <a:pPr algn="l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high   191 147 121  92   67    52   37   24   16    9     3     0</a:t>
            </a:r>
            <a:endParaRPr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タイトル 1"/>
          <p:cNvSpPr txBox="1">
            <a:spLocks/>
          </p:cNvSpPr>
          <p:nvPr/>
        </p:nvSpPr>
        <p:spPr>
          <a:xfrm>
            <a:off x="4834548" y="4324583"/>
            <a:ext cx="4144743" cy="724074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No. at risk</a:t>
            </a:r>
          </a:p>
          <a:p>
            <a:pPr algn="l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low    762  655 581 492 411 362 288 193 123   56   18    0</a:t>
            </a:r>
          </a:p>
          <a:p>
            <a:pPr algn="l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high   314 250 213 160 127   90   67   47   35   19    </a:t>
            </a:r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3</a:t>
            </a:r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     0</a:t>
            </a:r>
            <a:endParaRPr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タイトル 1"/>
          <p:cNvSpPr txBox="1">
            <a:spLocks/>
          </p:cNvSpPr>
          <p:nvPr/>
        </p:nvSpPr>
        <p:spPr>
          <a:xfrm rot="16200000">
            <a:off x="-404531" y="3036894"/>
            <a:ext cx="2296391" cy="586558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ease-fre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rvival 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タイトル 1"/>
          <p:cNvSpPr txBox="1">
            <a:spLocks/>
          </p:cNvSpPr>
          <p:nvPr/>
        </p:nvSpPr>
        <p:spPr>
          <a:xfrm rot="16200000">
            <a:off x="3843098" y="3036894"/>
            <a:ext cx="2296391" cy="586558"/>
          </a:xfrm>
          <a:prstGeom prst="rect">
            <a:avLst/>
          </a:prstGeom>
          <a:ln w="19050"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ease-fre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rvival 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43641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19</Words>
  <Application>Microsoft Office PowerPoint</Application>
  <PresentationFormat>On-screen Show (4:3)</PresentationFormat>
  <Paragraphs>2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ホワイト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今村 美智子</dc:creator>
  <cp:lastModifiedBy>Balindan, Danica Joy</cp:lastModifiedBy>
  <cp:revision>7</cp:revision>
  <dcterms:created xsi:type="dcterms:W3CDTF">2017-12-27T09:15:54Z</dcterms:created>
  <dcterms:modified xsi:type="dcterms:W3CDTF">2018-02-07T05:49:00Z</dcterms:modified>
</cp:coreProperties>
</file>